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C26E51-901A-45E5-A5E4-D5F82F76E3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0C5C5-F1C7-4FF3-974C-D5E3242D32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34E871-1D86-465E-929B-5754743EA7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FBF6A-FD6E-43D6-9A80-03976C8FB1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982B0-7301-43D0-8EC8-7C470B8511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B7D42-2C49-4D94-A5F2-6C6AF83F1D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343D8-8D37-45D4-9BC5-6A82E1FA58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8F9E6-B176-4C57-B5B8-6B9EEB8992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5310F-3A48-4E12-9A8B-383646E3DE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A65274-DBA1-4583-9153-6E5BAA9C40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B03B0-B3B3-4CD2-9D20-22EE6758C2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34D47-BB6D-4380-85B6-3521BE318A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5B2AC5-776B-46EC-9EE9-686FB466008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971440" y="8381880"/>
            <a:ext cx="9532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506240" y="1103400"/>
            <a:ext cx="25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00640" y="1093680"/>
            <a:ext cx="39240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pr</a:t>
            </a:r>
            <a:r>
              <a:rPr b="0" lang="en-US" sz="900" spc="-1" strike="noStrike" baseline="-25000">
                <a:solidFill>
                  <a:srgbClr val="000000"/>
                </a:solidFill>
                <a:latin typeface="Arial"/>
              </a:rPr>
              <a:t>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982880" y="1093680"/>
            <a:ext cx="371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I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569960" y="1104840"/>
            <a:ext cx="639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287440" y="1103400"/>
            <a:ext cx="25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442240" y="1093680"/>
            <a:ext cx="39240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pr</a:t>
            </a:r>
            <a:r>
              <a:rPr b="0" lang="en-US" sz="900" spc="-1" strike="noStrike" baseline="-25000">
                <a:solidFill>
                  <a:srgbClr val="000000"/>
                </a:solidFill>
                <a:latin typeface="Arial"/>
              </a:rPr>
              <a:t>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675160" y="1093680"/>
            <a:ext cx="371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I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542960" y="903240"/>
            <a:ext cx="75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ytoplas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363400" y="90324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ucleu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918360" y="2567160"/>
            <a:ext cx="604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4-3-3 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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889560" y="1790640"/>
            <a:ext cx="63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c25C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.S2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23960" y="2127240"/>
            <a:ext cx="79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k1-P.Y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073880" y="238608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88840" y="1351080"/>
            <a:ext cx="63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clinB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030320" y="3598920"/>
            <a:ext cx="491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R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1471680" y="3562200"/>
            <a:ext cx="1576440" cy="26064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1112760" y="3162240"/>
            <a:ext cx="35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p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1447920" y="3032280"/>
            <a:ext cx="0" cy="511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1471680" y="3270240"/>
            <a:ext cx="1576440" cy="27792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3"/>
          <a:stretch/>
        </p:blipFill>
        <p:spPr>
          <a:xfrm>
            <a:off x="1471680" y="3022560"/>
            <a:ext cx="1576440" cy="23328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1207440" y="2781360"/>
            <a:ext cx="315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i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" descr=""/>
          <p:cNvPicPr/>
          <p:nvPr/>
        </p:nvPicPr>
        <p:blipFill>
          <a:blip r:embed="rId4"/>
          <a:stretch/>
        </p:blipFill>
        <p:spPr>
          <a:xfrm>
            <a:off x="1471680" y="2781360"/>
            <a:ext cx="1576440" cy="22680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1118160" y="159696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lk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5"/>
          <a:stretch/>
        </p:blipFill>
        <p:spPr>
          <a:xfrm>
            <a:off x="1471680" y="1590840"/>
            <a:ext cx="1576440" cy="22680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6"/>
          <a:stretch/>
        </p:blipFill>
        <p:spPr>
          <a:xfrm>
            <a:off x="1471680" y="3836880"/>
            <a:ext cx="1576440" cy="216000"/>
          </a:xfrm>
          <a:prstGeom prst="rect">
            <a:avLst/>
          </a:prstGeom>
          <a:ln w="0">
            <a:noFill/>
          </a:ln>
        </p:spPr>
      </p:pic>
      <p:sp>
        <p:nvSpPr>
          <p:cNvPr id="67" name=""/>
          <p:cNvSpPr/>
          <p:nvPr/>
        </p:nvSpPr>
        <p:spPr>
          <a:xfrm>
            <a:off x="935640" y="3827520"/>
            <a:ext cx="586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" descr=""/>
          <p:cNvPicPr/>
          <p:nvPr/>
        </p:nvPicPr>
        <p:blipFill>
          <a:blip r:embed="rId7"/>
          <a:stretch/>
        </p:blipFill>
        <p:spPr>
          <a:xfrm>
            <a:off x="1471680" y="1832040"/>
            <a:ext cx="1574640" cy="54288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8"/>
          <a:stretch/>
        </p:blipFill>
        <p:spPr>
          <a:xfrm>
            <a:off x="1471680" y="1285920"/>
            <a:ext cx="1574640" cy="29052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9"/>
          <a:stretch/>
        </p:blipFill>
        <p:spPr>
          <a:xfrm>
            <a:off x="1471680" y="2616120"/>
            <a:ext cx="1574640" cy="150840"/>
          </a:xfrm>
          <a:prstGeom prst="rect">
            <a:avLst/>
          </a:prstGeom>
          <a:ln w="0">
            <a:noFill/>
          </a:ln>
        </p:spPr>
      </p:pic>
      <p:pic>
        <p:nvPicPr>
          <p:cNvPr id="71" name="" descr=""/>
          <p:cNvPicPr/>
          <p:nvPr/>
        </p:nvPicPr>
        <p:blipFill>
          <a:blip r:embed="rId10"/>
          <a:stretch/>
        </p:blipFill>
        <p:spPr>
          <a:xfrm>
            <a:off x="1471680" y="2389320"/>
            <a:ext cx="1576440" cy="212760"/>
          </a:xfrm>
          <a:prstGeom prst="rect">
            <a:avLst/>
          </a:prstGeom>
          <a:ln w="0">
            <a:noFill/>
          </a:ln>
        </p:spPr>
      </p:pic>
      <p:sp>
        <p:nvSpPr>
          <p:cNvPr id="72" name=""/>
          <p:cNvSpPr/>
          <p:nvPr/>
        </p:nvSpPr>
        <p:spPr>
          <a:xfrm>
            <a:off x="763920" y="5335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332080" y="1104840"/>
            <a:ext cx="639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421440" y="5335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" descr=""/>
          <p:cNvPicPr/>
          <p:nvPr/>
        </p:nvPicPr>
        <p:blipFill>
          <a:blip r:embed="rId11"/>
          <a:stretch/>
        </p:blipFill>
        <p:spPr>
          <a:xfrm>
            <a:off x="4206960" y="1279440"/>
            <a:ext cx="593640" cy="16848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12"/>
          <a:stretch/>
        </p:blipFill>
        <p:spPr>
          <a:xfrm>
            <a:off x="4206960" y="1116000"/>
            <a:ext cx="593640" cy="146160"/>
          </a:xfrm>
          <a:prstGeom prst="rect">
            <a:avLst/>
          </a:prstGeom>
          <a:ln w="0">
            <a:noFill/>
          </a:ln>
        </p:spPr>
      </p:pic>
      <p:pic>
        <p:nvPicPr>
          <p:cNvPr id="77" name="" descr=""/>
          <p:cNvPicPr/>
          <p:nvPr/>
        </p:nvPicPr>
        <p:blipFill>
          <a:blip r:embed="rId13"/>
          <a:stretch/>
        </p:blipFill>
        <p:spPr>
          <a:xfrm>
            <a:off x="4206960" y="1467000"/>
            <a:ext cx="593640" cy="172800"/>
          </a:xfrm>
          <a:prstGeom prst="rect">
            <a:avLst/>
          </a:prstGeom>
          <a:ln w="0">
            <a:noFill/>
          </a:ln>
        </p:spPr>
      </p:pic>
      <p:pic>
        <p:nvPicPr>
          <p:cNvPr id="78" name="" descr=""/>
          <p:cNvPicPr/>
          <p:nvPr/>
        </p:nvPicPr>
        <p:blipFill>
          <a:blip r:embed="rId14"/>
          <a:stretch/>
        </p:blipFill>
        <p:spPr>
          <a:xfrm>
            <a:off x="4206960" y="1657440"/>
            <a:ext cx="593640" cy="187200"/>
          </a:xfrm>
          <a:prstGeom prst="rect">
            <a:avLst/>
          </a:prstGeom>
          <a:ln w="0">
            <a:noFill/>
          </a:ln>
        </p:spPr>
      </p:pic>
      <p:sp>
        <p:nvSpPr>
          <p:cNvPr id="79" name=""/>
          <p:cNvSpPr/>
          <p:nvPr/>
        </p:nvSpPr>
        <p:spPr>
          <a:xfrm>
            <a:off x="3564720" y="1066680"/>
            <a:ext cx="71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803400" y="12412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k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903840" y="162864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p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889080" y="143208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191480" y="685800"/>
            <a:ext cx="62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iri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867480" y="893880"/>
            <a:ext cx="41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pr: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500360" y="87948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221000" y="831960"/>
            <a:ext cx="257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245120" y="927000"/>
            <a:ext cx="527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704600" y="722160"/>
            <a:ext cx="1119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ll fraction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554120" y="932040"/>
            <a:ext cx="1417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1T21:45:23Z</dcterms:created>
  <dc:creator>N. I. A. I. D. N. I. H.</dc:creator>
  <dc:description/>
  <dc:language>en-US</dc:language>
  <cp:lastModifiedBy>N. I. A. I. D. N. I. H.</cp:lastModifiedBy>
  <dcterms:modified xsi:type="dcterms:W3CDTF">2008-03-11T21:48:08Z</dcterms:modified>
  <cp:revision>11</cp:revision>
  <dc:subject/>
  <dc:title>PowerPoint Presentation</dc:title>
</cp:coreProperties>
</file>